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2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52" d="100"/>
          <a:sy n="152" d="100"/>
        </p:scale>
        <p:origin x="198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8/05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0940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8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347451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ughton and Hovorka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65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w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225005"/>
            <a:ext cx="88979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 closed-loop ecosystem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7629C84-FB71-3295-7C5F-DE20E1ABCC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19772" y="908720"/>
            <a:ext cx="4104456" cy="46865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9463" y="267212"/>
            <a:ext cx="888581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ariability of day-to-day insulin requirements as determined by closed-loop insulin delivery across different populations with diabetes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8504048-6826-8CBF-1644-B5D5A6CB22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66905" y="1447617"/>
            <a:ext cx="3505295" cy="411423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3487C9E-FA07-31C1-FAAB-C3852667E258}"/>
              </a:ext>
            </a:extLst>
          </p:cNvPr>
          <p:cNvSpPr txBox="1"/>
          <p:nvPr/>
        </p:nvSpPr>
        <p:spPr>
          <a:xfrm>
            <a:off x="395536" y="5347451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ughton and Hovorka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65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w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1563692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1</Words>
  <Application>Microsoft Office PowerPoint</Application>
  <PresentationFormat>On-screen Show (4:3)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7</cp:revision>
  <dcterms:created xsi:type="dcterms:W3CDTF">2016-06-15T12:53:43Z</dcterms:created>
  <dcterms:modified xsi:type="dcterms:W3CDTF">2024-05-08T13:55:46Z</dcterms:modified>
</cp:coreProperties>
</file>